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0" r:id="rId2"/>
    <p:sldId id="272" r:id="rId3"/>
    <p:sldId id="265" r:id="rId4"/>
  </p:sldIdLst>
  <p:sldSz cx="5238750" cy="84661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67" userDrawn="1">
          <p15:clr>
            <a:srgbClr val="A4A3A4"/>
          </p15:clr>
        </p15:guide>
        <p15:guide id="2" pos="165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145" autoAdjust="0"/>
    <p:restoredTop sz="94660"/>
  </p:normalViewPr>
  <p:slideViewPr>
    <p:cSldViewPr showGuides="1">
      <p:cViewPr varScale="1">
        <p:scale>
          <a:sx n="91" d="100"/>
          <a:sy n="91" d="100"/>
        </p:scale>
        <p:origin x="3360" y="84"/>
      </p:cViewPr>
      <p:guideLst>
        <p:guide orient="horz" pos="2667"/>
        <p:guide pos="165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45000" cy="45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92906" y="1385547"/>
            <a:ext cx="4452938" cy="2947470"/>
          </a:xfrm>
        </p:spPr>
        <p:txBody>
          <a:bodyPr anchor="b"/>
          <a:lstStyle>
            <a:lvl1pPr algn="ctr">
              <a:defRPr sz="3437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54844" y="4446683"/>
            <a:ext cx="3929063" cy="2044023"/>
          </a:xfrm>
        </p:spPr>
        <p:txBody>
          <a:bodyPr/>
          <a:lstStyle>
            <a:lvl1pPr marL="0" indent="0" algn="ctr">
              <a:buNone/>
              <a:defRPr sz="1375"/>
            </a:lvl1pPr>
            <a:lvl2pPr marL="261930" indent="0" algn="ctr">
              <a:buNone/>
              <a:defRPr sz="1146"/>
            </a:lvl2pPr>
            <a:lvl3pPr marL="523860" indent="0" algn="ctr">
              <a:buNone/>
              <a:defRPr sz="1031"/>
            </a:lvl3pPr>
            <a:lvl4pPr marL="785790" indent="0" algn="ctr">
              <a:buNone/>
              <a:defRPr sz="917"/>
            </a:lvl4pPr>
            <a:lvl5pPr marL="1047720" indent="0" algn="ctr">
              <a:buNone/>
              <a:defRPr sz="917"/>
            </a:lvl5pPr>
            <a:lvl6pPr marL="1309649" indent="0" algn="ctr">
              <a:buNone/>
              <a:defRPr sz="917"/>
            </a:lvl6pPr>
            <a:lvl7pPr marL="1571579" indent="0" algn="ctr">
              <a:buNone/>
              <a:defRPr sz="917"/>
            </a:lvl7pPr>
            <a:lvl8pPr marL="1833509" indent="0" algn="ctr">
              <a:buNone/>
              <a:defRPr sz="917"/>
            </a:lvl8pPr>
            <a:lvl9pPr marL="2095439" indent="0" algn="ctr">
              <a:buNone/>
              <a:defRPr sz="917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0B3C7-E812-4D9C-A08A-A847AF40A43E}" type="datetimeFigureOut">
              <a:rPr lang="de-DE" smtClean="0"/>
              <a:t>17.0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B065E-8387-46BB-8DDD-2E8DB95340B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929239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0B3C7-E812-4D9C-A08A-A847AF40A43E}" type="datetimeFigureOut">
              <a:rPr lang="de-DE" smtClean="0"/>
              <a:t>17.0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B065E-8387-46BB-8DDD-2E8DB95340B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508619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48981" y="450743"/>
            <a:ext cx="1129605" cy="7174661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60164" y="450743"/>
            <a:ext cx="3323332" cy="7174661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0B3C7-E812-4D9C-A08A-A847AF40A43E}" type="datetimeFigureOut">
              <a:rPr lang="de-DE" smtClean="0"/>
              <a:t>17.0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B065E-8387-46BB-8DDD-2E8DB95340B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84309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0B3C7-E812-4D9C-A08A-A847AF40A43E}" type="datetimeFigureOut">
              <a:rPr lang="de-DE" smtClean="0"/>
              <a:t>17.0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B065E-8387-46BB-8DDD-2E8DB95340B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417063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7436" y="2110658"/>
            <a:ext cx="4518422" cy="3521678"/>
          </a:xfrm>
        </p:spPr>
        <p:txBody>
          <a:bodyPr anchor="b"/>
          <a:lstStyle>
            <a:lvl1pPr>
              <a:defRPr sz="3437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7436" y="5665652"/>
            <a:ext cx="4518422" cy="1851967"/>
          </a:xfrm>
        </p:spPr>
        <p:txBody>
          <a:bodyPr/>
          <a:lstStyle>
            <a:lvl1pPr marL="0" indent="0">
              <a:buNone/>
              <a:defRPr sz="1375">
                <a:solidFill>
                  <a:schemeClr val="tx1"/>
                </a:solidFill>
              </a:defRPr>
            </a:lvl1pPr>
            <a:lvl2pPr marL="261930" indent="0">
              <a:buNone/>
              <a:defRPr sz="1146">
                <a:solidFill>
                  <a:schemeClr val="tx1">
                    <a:tint val="75000"/>
                  </a:schemeClr>
                </a:solidFill>
              </a:defRPr>
            </a:lvl2pPr>
            <a:lvl3pPr marL="523860" indent="0">
              <a:buNone/>
              <a:defRPr sz="1031">
                <a:solidFill>
                  <a:schemeClr val="tx1">
                    <a:tint val="75000"/>
                  </a:schemeClr>
                </a:solidFill>
              </a:defRPr>
            </a:lvl3pPr>
            <a:lvl4pPr marL="785790" indent="0">
              <a:buNone/>
              <a:defRPr sz="917">
                <a:solidFill>
                  <a:schemeClr val="tx1">
                    <a:tint val="75000"/>
                  </a:schemeClr>
                </a:solidFill>
              </a:defRPr>
            </a:lvl4pPr>
            <a:lvl5pPr marL="1047720" indent="0">
              <a:buNone/>
              <a:defRPr sz="917">
                <a:solidFill>
                  <a:schemeClr val="tx1">
                    <a:tint val="75000"/>
                  </a:schemeClr>
                </a:solidFill>
              </a:defRPr>
            </a:lvl5pPr>
            <a:lvl6pPr marL="1309649" indent="0">
              <a:buNone/>
              <a:defRPr sz="917">
                <a:solidFill>
                  <a:schemeClr val="tx1">
                    <a:tint val="75000"/>
                  </a:schemeClr>
                </a:solidFill>
              </a:defRPr>
            </a:lvl6pPr>
            <a:lvl7pPr marL="1571579" indent="0">
              <a:buNone/>
              <a:defRPr sz="917">
                <a:solidFill>
                  <a:schemeClr val="tx1">
                    <a:tint val="75000"/>
                  </a:schemeClr>
                </a:solidFill>
              </a:defRPr>
            </a:lvl7pPr>
            <a:lvl8pPr marL="1833509" indent="0">
              <a:buNone/>
              <a:defRPr sz="917">
                <a:solidFill>
                  <a:schemeClr val="tx1">
                    <a:tint val="75000"/>
                  </a:schemeClr>
                </a:solidFill>
              </a:defRPr>
            </a:lvl8pPr>
            <a:lvl9pPr marL="2095439" indent="0">
              <a:buNone/>
              <a:defRPr sz="91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0B3C7-E812-4D9C-A08A-A847AF40A43E}" type="datetimeFigureOut">
              <a:rPr lang="de-DE" smtClean="0"/>
              <a:t>17.0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B065E-8387-46BB-8DDD-2E8DB95340B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439451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60164" y="2253717"/>
            <a:ext cx="2226469" cy="5371687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52117" y="2253717"/>
            <a:ext cx="2226469" cy="5371687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0B3C7-E812-4D9C-A08A-A847AF40A43E}" type="datetimeFigureOut">
              <a:rPr lang="de-DE" smtClean="0"/>
              <a:t>17.01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B065E-8387-46BB-8DDD-2E8DB95340B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228415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0846" y="450745"/>
            <a:ext cx="4518422" cy="1636395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0847" y="2075380"/>
            <a:ext cx="2216236" cy="1017112"/>
          </a:xfrm>
        </p:spPr>
        <p:txBody>
          <a:bodyPr anchor="b"/>
          <a:lstStyle>
            <a:lvl1pPr marL="0" indent="0">
              <a:buNone/>
              <a:defRPr sz="1375" b="1"/>
            </a:lvl1pPr>
            <a:lvl2pPr marL="261930" indent="0">
              <a:buNone/>
              <a:defRPr sz="1146" b="1"/>
            </a:lvl2pPr>
            <a:lvl3pPr marL="523860" indent="0">
              <a:buNone/>
              <a:defRPr sz="1031" b="1"/>
            </a:lvl3pPr>
            <a:lvl4pPr marL="785790" indent="0">
              <a:buNone/>
              <a:defRPr sz="917" b="1"/>
            </a:lvl4pPr>
            <a:lvl5pPr marL="1047720" indent="0">
              <a:buNone/>
              <a:defRPr sz="917" b="1"/>
            </a:lvl5pPr>
            <a:lvl6pPr marL="1309649" indent="0">
              <a:buNone/>
              <a:defRPr sz="917" b="1"/>
            </a:lvl6pPr>
            <a:lvl7pPr marL="1571579" indent="0">
              <a:buNone/>
              <a:defRPr sz="917" b="1"/>
            </a:lvl7pPr>
            <a:lvl8pPr marL="1833509" indent="0">
              <a:buNone/>
              <a:defRPr sz="917" b="1"/>
            </a:lvl8pPr>
            <a:lvl9pPr marL="2095439" indent="0">
              <a:buNone/>
              <a:defRPr sz="917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0847" y="3092492"/>
            <a:ext cx="2216236" cy="4548590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652118" y="2075380"/>
            <a:ext cx="2227151" cy="1017112"/>
          </a:xfrm>
        </p:spPr>
        <p:txBody>
          <a:bodyPr anchor="b"/>
          <a:lstStyle>
            <a:lvl1pPr marL="0" indent="0">
              <a:buNone/>
              <a:defRPr sz="1375" b="1"/>
            </a:lvl1pPr>
            <a:lvl2pPr marL="261930" indent="0">
              <a:buNone/>
              <a:defRPr sz="1146" b="1"/>
            </a:lvl2pPr>
            <a:lvl3pPr marL="523860" indent="0">
              <a:buNone/>
              <a:defRPr sz="1031" b="1"/>
            </a:lvl3pPr>
            <a:lvl4pPr marL="785790" indent="0">
              <a:buNone/>
              <a:defRPr sz="917" b="1"/>
            </a:lvl4pPr>
            <a:lvl5pPr marL="1047720" indent="0">
              <a:buNone/>
              <a:defRPr sz="917" b="1"/>
            </a:lvl5pPr>
            <a:lvl6pPr marL="1309649" indent="0">
              <a:buNone/>
              <a:defRPr sz="917" b="1"/>
            </a:lvl6pPr>
            <a:lvl7pPr marL="1571579" indent="0">
              <a:buNone/>
              <a:defRPr sz="917" b="1"/>
            </a:lvl7pPr>
            <a:lvl8pPr marL="1833509" indent="0">
              <a:buNone/>
              <a:defRPr sz="917" b="1"/>
            </a:lvl8pPr>
            <a:lvl9pPr marL="2095439" indent="0">
              <a:buNone/>
              <a:defRPr sz="917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652118" y="3092492"/>
            <a:ext cx="2227151" cy="4548590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0B3C7-E812-4D9C-A08A-A847AF40A43E}" type="datetimeFigureOut">
              <a:rPr lang="de-DE" smtClean="0"/>
              <a:t>17.01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B065E-8387-46BB-8DDD-2E8DB95340B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84385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0B3C7-E812-4D9C-A08A-A847AF40A43E}" type="datetimeFigureOut">
              <a:rPr lang="de-DE" smtClean="0"/>
              <a:t>17.01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B065E-8387-46BB-8DDD-2E8DB95340B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48382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0B3C7-E812-4D9C-A08A-A847AF40A43E}" type="datetimeFigureOut">
              <a:rPr lang="de-DE" smtClean="0"/>
              <a:t>17.01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B065E-8387-46BB-8DDD-2E8DB95340B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058102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0847" y="564409"/>
            <a:ext cx="1689633" cy="1975432"/>
          </a:xfrm>
        </p:spPr>
        <p:txBody>
          <a:bodyPr anchor="b"/>
          <a:lstStyle>
            <a:lvl1pPr>
              <a:defRPr sz="1833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227151" y="1218969"/>
            <a:ext cx="2652117" cy="6016445"/>
          </a:xfrm>
        </p:spPr>
        <p:txBody>
          <a:bodyPr/>
          <a:lstStyle>
            <a:lvl1pPr>
              <a:defRPr sz="1833"/>
            </a:lvl1pPr>
            <a:lvl2pPr>
              <a:defRPr sz="1604"/>
            </a:lvl2pPr>
            <a:lvl3pPr>
              <a:defRPr sz="1375"/>
            </a:lvl3pPr>
            <a:lvl4pPr>
              <a:defRPr sz="1146"/>
            </a:lvl4pPr>
            <a:lvl5pPr>
              <a:defRPr sz="1146"/>
            </a:lvl5pPr>
            <a:lvl6pPr>
              <a:defRPr sz="1146"/>
            </a:lvl6pPr>
            <a:lvl7pPr>
              <a:defRPr sz="1146"/>
            </a:lvl7pPr>
            <a:lvl8pPr>
              <a:defRPr sz="1146"/>
            </a:lvl8pPr>
            <a:lvl9pPr>
              <a:defRPr sz="1146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60847" y="2539842"/>
            <a:ext cx="1689633" cy="4705370"/>
          </a:xfrm>
        </p:spPr>
        <p:txBody>
          <a:bodyPr/>
          <a:lstStyle>
            <a:lvl1pPr marL="0" indent="0">
              <a:buNone/>
              <a:defRPr sz="917"/>
            </a:lvl1pPr>
            <a:lvl2pPr marL="261930" indent="0">
              <a:buNone/>
              <a:defRPr sz="802"/>
            </a:lvl2pPr>
            <a:lvl3pPr marL="523860" indent="0">
              <a:buNone/>
              <a:defRPr sz="687"/>
            </a:lvl3pPr>
            <a:lvl4pPr marL="785790" indent="0">
              <a:buNone/>
              <a:defRPr sz="573"/>
            </a:lvl4pPr>
            <a:lvl5pPr marL="1047720" indent="0">
              <a:buNone/>
              <a:defRPr sz="573"/>
            </a:lvl5pPr>
            <a:lvl6pPr marL="1309649" indent="0">
              <a:buNone/>
              <a:defRPr sz="573"/>
            </a:lvl6pPr>
            <a:lvl7pPr marL="1571579" indent="0">
              <a:buNone/>
              <a:defRPr sz="573"/>
            </a:lvl7pPr>
            <a:lvl8pPr marL="1833509" indent="0">
              <a:buNone/>
              <a:defRPr sz="573"/>
            </a:lvl8pPr>
            <a:lvl9pPr marL="2095439" indent="0">
              <a:buNone/>
              <a:defRPr sz="573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0B3C7-E812-4D9C-A08A-A847AF40A43E}" type="datetimeFigureOut">
              <a:rPr lang="de-DE" smtClean="0"/>
              <a:t>17.01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B065E-8387-46BB-8DDD-2E8DB95340B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490127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0847" y="564409"/>
            <a:ext cx="1689633" cy="1975432"/>
          </a:xfrm>
        </p:spPr>
        <p:txBody>
          <a:bodyPr anchor="b"/>
          <a:lstStyle>
            <a:lvl1pPr>
              <a:defRPr sz="1833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227151" y="1218969"/>
            <a:ext cx="2652117" cy="6016445"/>
          </a:xfrm>
        </p:spPr>
        <p:txBody>
          <a:bodyPr anchor="t"/>
          <a:lstStyle>
            <a:lvl1pPr marL="0" indent="0">
              <a:buNone/>
              <a:defRPr sz="1833"/>
            </a:lvl1pPr>
            <a:lvl2pPr marL="261930" indent="0">
              <a:buNone/>
              <a:defRPr sz="1604"/>
            </a:lvl2pPr>
            <a:lvl3pPr marL="523860" indent="0">
              <a:buNone/>
              <a:defRPr sz="1375"/>
            </a:lvl3pPr>
            <a:lvl4pPr marL="785790" indent="0">
              <a:buNone/>
              <a:defRPr sz="1146"/>
            </a:lvl4pPr>
            <a:lvl5pPr marL="1047720" indent="0">
              <a:buNone/>
              <a:defRPr sz="1146"/>
            </a:lvl5pPr>
            <a:lvl6pPr marL="1309649" indent="0">
              <a:buNone/>
              <a:defRPr sz="1146"/>
            </a:lvl6pPr>
            <a:lvl7pPr marL="1571579" indent="0">
              <a:buNone/>
              <a:defRPr sz="1146"/>
            </a:lvl7pPr>
            <a:lvl8pPr marL="1833509" indent="0">
              <a:buNone/>
              <a:defRPr sz="1146"/>
            </a:lvl8pPr>
            <a:lvl9pPr marL="2095439" indent="0">
              <a:buNone/>
              <a:defRPr sz="1146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60847" y="2539842"/>
            <a:ext cx="1689633" cy="4705370"/>
          </a:xfrm>
        </p:spPr>
        <p:txBody>
          <a:bodyPr/>
          <a:lstStyle>
            <a:lvl1pPr marL="0" indent="0">
              <a:buNone/>
              <a:defRPr sz="917"/>
            </a:lvl1pPr>
            <a:lvl2pPr marL="261930" indent="0">
              <a:buNone/>
              <a:defRPr sz="802"/>
            </a:lvl2pPr>
            <a:lvl3pPr marL="523860" indent="0">
              <a:buNone/>
              <a:defRPr sz="687"/>
            </a:lvl3pPr>
            <a:lvl4pPr marL="785790" indent="0">
              <a:buNone/>
              <a:defRPr sz="573"/>
            </a:lvl4pPr>
            <a:lvl5pPr marL="1047720" indent="0">
              <a:buNone/>
              <a:defRPr sz="573"/>
            </a:lvl5pPr>
            <a:lvl6pPr marL="1309649" indent="0">
              <a:buNone/>
              <a:defRPr sz="573"/>
            </a:lvl6pPr>
            <a:lvl7pPr marL="1571579" indent="0">
              <a:buNone/>
              <a:defRPr sz="573"/>
            </a:lvl7pPr>
            <a:lvl8pPr marL="1833509" indent="0">
              <a:buNone/>
              <a:defRPr sz="573"/>
            </a:lvl8pPr>
            <a:lvl9pPr marL="2095439" indent="0">
              <a:buNone/>
              <a:defRPr sz="573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0B3C7-E812-4D9C-A08A-A847AF40A43E}" type="datetimeFigureOut">
              <a:rPr lang="de-DE" smtClean="0"/>
              <a:t>17.01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B065E-8387-46BB-8DDD-2E8DB95340B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65827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60164" y="450745"/>
            <a:ext cx="4518422" cy="16363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0164" y="2253717"/>
            <a:ext cx="4518422" cy="53716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60164" y="7846858"/>
            <a:ext cx="1178719" cy="45074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8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80B3C7-E812-4D9C-A08A-A847AF40A43E}" type="datetimeFigureOut">
              <a:rPr lang="de-DE" smtClean="0"/>
              <a:t>17.0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735336" y="7846858"/>
            <a:ext cx="1768078" cy="45074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8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699867" y="7846858"/>
            <a:ext cx="1178719" cy="45074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8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3B065E-8387-46BB-8DDD-2E8DB95340B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482743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23860" rtl="0" eaLnBrk="1" latinLnBrk="0" hangingPunct="1">
        <a:lnSpc>
          <a:spcPct val="90000"/>
        </a:lnSpc>
        <a:spcBef>
          <a:spcPct val="0"/>
        </a:spcBef>
        <a:buNone/>
        <a:defRPr sz="252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0965" indent="-130965" algn="l" defTabSz="523860" rtl="0" eaLnBrk="1" latinLnBrk="0" hangingPunct="1">
        <a:lnSpc>
          <a:spcPct val="90000"/>
        </a:lnSpc>
        <a:spcBef>
          <a:spcPts val="573"/>
        </a:spcBef>
        <a:buFont typeface="Arial" panose="020B0604020202020204" pitchFamily="34" charset="0"/>
        <a:buChar char="•"/>
        <a:defRPr sz="1604" kern="1200">
          <a:solidFill>
            <a:schemeClr val="tx1"/>
          </a:solidFill>
          <a:latin typeface="+mn-lt"/>
          <a:ea typeface="+mn-ea"/>
          <a:cs typeface="+mn-cs"/>
        </a:defRPr>
      </a:lvl1pPr>
      <a:lvl2pPr marL="392895" indent="-130965" algn="l" defTabSz="523860" rtl="0" eaLnBrk="1" latinLnBrk="0" hangingPunct="1">
        <a:lnSpc>
          <a:spcPct val="90000"/>
        </a:lnSpc>
        <a:spcBef>
          <a:spcPts val="286"/>
        </a:spcBef>
        <a:buFont typeface="Arial" panose="020B0604020202020204" pitchFamily="34" charset="0"/>
        <a:buChar char="•"/>
        <a:defRPr sz="1375" kern="1200">
          <a:solidFill>
            <a:schemeClr val="tx1"/>
          </a:solidFill>
          <a:latin typeface="+mn-lt"/>
          <a:ea typeface="+mn-ea"/>
          <a:cs typeface="+mn-cs"/>
        </a:defRPr>
      </a:lvl2pPr>
      <a:lvl3pPr marL="654825" indent="-130965" algn="l" defTabSz="523860" rtl="0" eaLnBrk="1" latinLnBrk="0" hangingPunct="1">
        <a:lnSpc>
          <a:spcPct val="90000"/>
        </a:lnSpc>
        <a:spcBef>
          <a:spcPts val="286"/>
        </a:spcBef>
        <a:buFont typeface="Arial" panose="020B0604020202020204" pitchFamily="34" charset="0"/>
        <a:buChar char="•"/>
        <a:defRPr sz="1146" kern="1200">
          <a:solidFill>
            <a:schemeClr val="tx1"/>
          </a:solidFill>
          <a:latin typeface="+mn-lt"/>
          <a:ea typeface="+mn-ea"/>
          <a:cs typeface="+mn-cs"/>
        </a:defRPr>
      </a:lvl3pPr>
      <a:lvl4pPr marL="916755" indent="-130965" algn="l" defTabSz="523860" rtl="0" eaLnBrk="1" latinLnBrk="0" hangingPunct="1">
        <a:lnSpc>
          <a:spcPct val="90000"/>
        </a:lnSpc>
        <a:spcBef>
          <a:spcPts val="286"/>
        </a:spcBef>
        <a:buFont typeface="Arial" panose="020B0604020202020204" pitchFamily="34" charset="0"/>
        <a:buChar char="•"/>
        <a:defRPr sz="1031" kern="1200">
          <a:solidFill>
            <a:schemeClr val="tx1"/>
          </a:solidFill>
          <a:latin typeface="+mn-lt"/>
          <a:ea typeface="+mn-ea"/>
          <a:cs typeface="+mn-cs"/>
        </a:defRPr>
      </a:lvl4pPr>
      <a:lvl5pPr marL="1178684" indent="-130965" algn="l" defTabSz="523860" rtl="0" eaLnBrk="1" latinLnBrk="0" hangingPunct="1">
        <a:lnSpc>
          <a:spcPct val="90000"/>
        </a:lnSpc>
        <a:spcBef>
          <a:spcPts val="286"/>
        </a:spcBef>
        <a:buFont typeface="Arial" panose="020B0604020202020204" pitchFamily="34" charset="0"/>
        <a:buChar char="•"/>
        <a:defRPr sz="1031" kern="1200">
          <a:solidFill>
            <a:schemeClr val="tx1"/>
          </a:solidFill>
          <a:latin typeface="+mn-lt"/>
          <a:ea typeface="+mn-ea"/>
          <a:cs typeface="+mn-cs"/>
        </a:defRPr>
      </a:lvl5pPr>
      <a:lvl6pPr marL="1440614" indent="-130965" algn="l" defTabSz="523860" rtl="0" eaLnBrk="1" latinLnBrk="0" hangingPunct="1">
        <a:lnSpc>
          <a:spcPct val="90000"/>
        </a:lnSpc>
        <a:spcBef>
          <a:spcPts val="286"/>
        </a:spcBef>
        <a:buFont typeface="Arial" panose="020B0604020202020204" pitchFamily="34" charset="0"/>
        <a:buChar char="•"/>
        <a:defRPr sz="1031" kern="1200">
          <a:solidFill>
            <a:schemeClr val="tx1"/>
          </a:solidFill>
          <a:latin typeface="+mn-lt"/>
          <a:ea typeface="+mn-ea"/>
          <a:cs typeface="+mn-cs"/>
        </a:defRPr>
      </a:lvl6pPr>
      <a:lvl7pPr marL="1702544" indent="-130965" algn="l" defTabSz="523860" rtl="0" eaLnBrk="1" latinLnBrk="0" hangingPunct="1">
        <a:lnSpc>
          <a:spcPct val="90000"/>
        </a:lnSpc>
        <a:spcBef>
          <a:spcPts val="286"/>
        </a:spcBef>
        <a:buFont typeface="Arial" panose="020B0604020202020204" pitchFamily="34" charset="0"/>
        <a:buChar char="•"/>
        <a:defRPr sz="1031" kern="1200">
          <a:solidFill>
            <a:schemeClr val="tx1"/>
          </a:solidFill>
          <a:latin typeface="+mn-lt"/>
          <a:ea typeface="+mn-ea"/>
          <a:cs typeface="+mn-cs"/>
        </a:defRPr>
      </a:lvl7pPr>
      <a:lvl8pPr marL="1964474" indent="-130965" algn="l" defTabSz="523860" rtl="0" eaLnBrk="1" latinLnBrk="0" hangingPunct="1">
        <a:lnSpc>
          <a:spcPct val="90000"/>
        </a:lnSpc>
        <a:spcBef>
          <a:spcPts val="286"/>
        </a:spcBef>
        <a:buFont typeface="Arial" panose="020B0604020202020204" pitchFamily="34" charset="0"/>
        <a:buChar char="•"/>
        <a:defRPr sz="1031" kern="1200">
          <a:solidFill>
            <a:schemeClr val="tx1"/>
          </a:solidFill>
          <a:latin typeface="+mn-lt"/>
          <a:ea typeface="+mn-ea"/>
          <a:cs typeface="+mn-cs"/>
        </a:defRPr>
      </a:lvl8pPr>
      <a:lvl9pPr marL="2226404" indent="-130965" algn="l" defTabSz="523860" rtl="0" eaLnBrk="1" latinLnBrk="0" hangingPunct="1">
        <a:lnSpc>
          <a:spcPct val="90000"/>
        </a:lnSpc>
        <a:spcBef>
          <a:spcPts val="286"/>
        </a:spcBef>
        <a:buFont typeface="Arial" panose="020B0604020202020204" pitchFamily="34" charset="0"/>
        <a:buChar char="•"/>
        <a:defRPr sz="103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23860" rtl="0" eaLnBrk="1" latinLnBrk="0" hangingPunct="1">
        <a:defRPr sz="1031" kern="1200">
          <a:solidFill>
            <a:schemeClr val="tx1"/>
          </a:solidFill>
          <a:latin typeface="+mn-lt"/>
          <a:ea typeface="+mn-ea"/>
          <a:cs typeface="+mn-cs"/>
        </a:defRPr>
      </a:lvl1pPr>
      <a:lvl2pPr marL="261930" algn="l" defTabSz="523860" rtl="0" eaLnBrk="1" latinLnBrk="0" hangingPunct="1">
        <a:defRPr sz="1031" kern="1200">
          <a:solidFill>
            <a:schemeClr val="tx1"/>
          </a:solidFill>
          <a:latin typeface="+mn-lt"/>
          <a:ea typeface="+mn-ea"/>
          <a:cs typeface="+mn-cs"/>
        </a:defRPr>
      </a:lvl2pPr>
      <a:lvl3pPr marL="523860" algn="l" defTabSz="523860" rtl="0" eaLnBrk="1" latinLnBrk="0" hangingPunct="1">
        <a:defRPr sz="1031" kern="1200">
          <a:solidFill>
            <a:schemeClr val="tx1"/>
          </a:solidFill>
          <a:latin typeface="+mn-lt"/>
          <a:ea typeface="+mn-ea"/>
          <a:cs typeface="+mn-cs"/>
        </a:defRPr>
      </a:lvl3pPr>
      <a:lvl4pPr marL="785790" algn="l" defTabSz="523860" rtl="0" eaLnBrk="1" latinLnBrk="0" hangingPunct="1">
        <a:defRPr sz="1031" kern="1200">
          <a:solidFill>
            <a:schemeClr val="tx1"/>
          </a:solidFill>
          <a:latin typeface="+mn-lt"/>
          <a:ea typeface="+mn-ea"/>
          <a:cs typeface="+mn-cs"/>
        </a:defRPr>
      </a:lvl4pPr>
      <a:lvl5pPr marL="1047720" algn="l" defTabSz="523860" rtl="0" eaLnBrk="1" latinLnBrk="0" hangingPunct="1">
        <a:defRPr sz="1031" kern="1200">
          <a:solidFill>
            <a:schemeClr val="tx1"/>
          </a:solidFill>
          <a:latin typeface="+mn-lt"/>
          <a:ea typeface="+mn-ea"/>
          <a:cs typeface="+mn-cs"/>
        </a:defRPr>
      </a:lvl5pPr>
      <a:lvl6pPr marL="1309649" algn="l" defTabSz="523860" rtl="0" eaLnBrk="1" latinLnBrk="0" hangingPunct="1">
        <a:defRPr sz="1031" kern="1200">
          <a:solidFill>
            <a:schemeClr val="tx1"/>
          </a:solidFill>
          <a:latin typeface="+mn-lt"/>
          <a:ea typeface="+mn-ea"/>
          <a:cs typeface="+mn-cs"/>
        </a:defRPr>
      </a:lvl6pPr>
      <a:lvl7pPr marL="1571579" algn="l" defTabSz="523860" rtl="0" eaLnBrk="1" latinLnBrk="0" hangingPunct="1">
        <a:defRPr sz="1031" kern="1200">
          <a:solidFill>
            <a:schemeClr val="tx1"/>
          </a:solidFill>
          <a:latin typeface="+mn-lt"/>
          <a:ea typeface="+mn-ea"/>
          <a:cs typeface="+mn-cs"/>
        </a:defRPr>
      </a:lvl7pPr>
      <a:lvl8pPr marL="1833509" algn="l" defTabSz="523860" rtl="0" eaLnBrk="1" latinLnBrk="0" hangingPunct="1">
        <a:defRPr sz="1031" kern="1200">
          <a:solidFill>
            <a:schemeClr val="tx1"/>
          </a:solidFill>
          <a:latin typeface="+mn-lt"/>
          <a:ea typeface="+mn-ea"/>
          <a:cs typeface="+mn-cs"/>
        </a:defRPr>
      </a:lvl8pPr>
      <a:lvl9pPr marL="2095439" algn="l" defTabSz="523860" rtl="0" eaLnBrk="1" latinLnBrk="0" hangingPunct="1">
        <a:defRPr sz="103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feld 20">
            <a:extLst>
              <a:ext uri="{FF2B5EF4-FFF2-40B4-BE49-F238E27FC236}">
                <a16:creationId xmlns:a16="http://schemas.microsoft.com/office/drawing/2014/main" id="{ACC6612D-8E80-9110-8FCD-CCB721C0A156}"/>
              </a:ext>
            </a:extLst>
          </p:cNvPr>
          <p:cNvSpPr txBox="1"/>
          <p:nvPr/>
        </p:nvSpPr>
        <p:spPr>
          <a:xfrm>
            <a:off x="0" y="2921295"/>
            <a:ext cx="523875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/>
              <a:t>Supplementary Figure S1. Relative cerebellar weight. </a:t>
            </a:r>
            <a:r>
              <a:rPr lang="en-US" sz="1000" dirty="0"/>
              <a:t>Relative cerebellar weight of adult (30 weeks) and old (66 weeks) male and female C57BL/6Jrj mice receiving -TE, +TE or +</a:t>
            </a:r>
            <a:r>
              <a:rPr lang="en-US" sz="1000" dirty="0" err="1"/>
              <a:t>TE</a:t>
            </a:r>
            <a:r>
              <a:rPr lang="en-US" sz="1000" baseline="-25000" dirty="0" err="1"/>
              <a:t>aa</a:t>
            </a:r>
            <a:r>
              <a:rPr lang="en-US" sz="1000" dirty="0"/>
              <a:t> diet for 26 weeks. Data points shown with mean ± SEM. Statistical testing based on Three-Way ANOVA and Bonferroni post-hoc test with ***p &lt; 0.001. Detailed results of statistical testing summarized in Supplementary Table </a:t>
            </a:r>
            <a:endParaRPr lang="de-DE" sz="1000" b="1" dirty="0"/>
          </a:p>
        </p:txBody>
      </p:sp>
      <p:pic>
        <p:nvPicPr>
          <p:cNvPr id="24" name="Grafik 23" descr="Ein Bild, das Text, Screenshot enthält.&#10;&#10;Automatisch generierte Beschreibung">
            <a:extLst>
              <a:ext uri="{FF2B5EF4-FFF2-40B4-BE49-F238E27FC236}">
                <a16:creationId xmlns:a16="http://schemas.microsoft.com/office/drawing/2014/main" id="{48788D3F-2176-E6B4-5794-14D2B09DB737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507" y="3069"/>
            <a:ext cx="4745736" cy="29215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339856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069"/>
            <a:ext cx="5238750" cy="4671447"/>
          </a:xfrm>
          <a:prstGeom prst="rect">
            <a:avLst/>
          </a:prstGeom>
        </p:spPr>
      </p:pic>
      <p:sp>
        <p:nvSpPr>
          <p:cNvPr id="3" name="Textfeld 2">
            <a:extLst>
              <a:ext uri="{FF2B5EF4-FFF2-40B4-BE49-F238E27FC236}">
                <a16:creationId xmlns:a16="http://schemas.microsoft.com/office/drawing/2014/main" id="{ACC6612D-8E80-9110-8FCD-CCB721C0A156}"/>
              </a:ext>
            </a:extLst>
          </p:cNvPr>
          <p:cNvSpPr txBox="1"/>
          <p:nvPr/>
        </p:nvSpPr>
        <p:spPr>
          <a:xfrm>
            <a:off x="0" y="4676295"/>
            <a:ext cx="523875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/>
              <a:t>Supplementary Figure S2. Heat maps for correlation of cerebellar element levels and expression of selected transport-related genes. </a:t>
            </a:r>
            <a:r>
              <a:rPr lang="en-US" sz="1000" dirty="0"/>
              <a:t>Correlation of data of all animals (A) as well as age-correction with data of only adult (B) or old (C) animals. Statistical testing based on Spearman correlation with *p &lt; 0.05. </a:t>
            </a:r>
            <a:endParaRPr lang="de-DE" sz="1000" b="1" dirty="0"/>
          </a:p>
        </p:txBody>
      </p:sp>
    </p:spTree>
    <p:extLst>
      <p:ext uri="{BB962C8B-B14F-4D97-AF65-F5344CB8AC3E}">
        <p14:creationId xmlns:p14="http://schemas.microsoft.com/office/powerpoint/2010/main" val="28459285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5F1A5C8A-7C28-782D-B308-58879D25E4E5}"/>
              </a:ext>
            </a:extLst>
          </p:cNvPr>
          <p:cNvSpPr txBox="1"/>
          <p:nvPr/>
        </p:nvSpPr>
        <p:spPr>
          <a:xfrm>
            <a:off x="0" y="3063069"/>
            <a:ext cx="523875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/>
              <a:t>Supplementary Figure S3. Impact of storage time on DNA strand breaks and alkali-labile sites assessed by alkaline comet assay.</a:t>
            </a:r>
            <a:r>
              <a:rPr lang="en-US" sz="1000" dirty="0"/>
              <a:t> Evaluation of DNA damage levels in cerebellum tissue of adult (22 weeks) male C57BL/6Jrj mice (n = 5) prepared from fresh tissue or frozen for time periods from one week to 12 months. Data shown as mean ± SEM. Statistical testing based on One-Way ANOVA and Dunnett’s post-hoc test with *p &lt; 0.05, ***p &lt; 0.001.</a:t>
            </a:r>
            <a:endParaRPr lang="de-DE" sz="1000" dirty="0"/>
          </a:p>
        </p:txBody>
      </p:sp>
      <p:pic>
        <p:nvPicPr>
          <p:cNvPr id="5" name="Grafik 4" descr="Ein Bild, das Screenshot, Schwarz, Grafiken, Design enthält.&#10;&#10;Automatisch generierte Beschreibung">
            <a:extLst>
              <a:ext uri="{FF2B5EF4-FFF2-40B4-BE49-F238E27FC236}">
                <a16:creationId xmlns:a16="http://schemas.microsoft.com/office/drawing/2014/main" id="{AF839BBF-0986-3CAC-BB3D-D563B85BDBFF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6825" y="3069"/>
            <a:ext cx="2705100" cy="28933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16116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25</Words>
  <Application>Microsoft Office PowerPoint</Application>
  <PresentationFormat>Custom</PresentationFormat>
  <Paragraphs>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harleen Friese</dc:creator>
  <cp:lastModifiedBy>Shirley Letts</cp:lastModifiedBy>
  <cp:revision>60</cp:revision>
  <dcterms:created xsi:type="dcterms:W3CDTF">2022-05-13T12:07:09Z</dcterms:created>
  <dcterms:modified xsi:type="dcterms:W3CDTF">2024-01-17T21:43:00Z</dcterms:modified>
</cp:coreProperties>
</file>